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" id="{49E882F5-072D-DF4F-92E7-EF0AD4F7E177}">
          <p14:sldIdLst>
            <p14:sldId id="268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68B"/>
    <a:srgbClr val="FF24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69"/>
    <p:restoredTop sz="97674"/>
  </p:normalViewPr>
  <p:slideViewPr>
    <p:cSldViewPr snapToGrid="0">
      <p:cViewPr>
        <p:scale>
          <a:sx n="98" d="100"/>
          <a:sy n="98" d="100"/>
        </p:scale>
        <p:origin x="3000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6E5109-D852-D04E-B9E8-0C8B47B42F75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460014-EC34-1548-9FB8-4F8B94B69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437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381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983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862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06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923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83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925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252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095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443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854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076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CC9FF1A-3B05-CAA3-3A1C-109E684DFD0C}"/>
              </a:ext>
            </a:extLst>
          </p:cNvPr>
          <p:cNvSpPr txBox="1"/>
          <p:nvPr/>
        </p:nvSpPr>
        <p:spPr>
          <a:xfrm>
            <a:off x="0" y="0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S9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7CE5575-6541-5E5C-80CD-C60895FFB118}"/>
              </a:ext>
            </a:extLst>
          </p:cNvPr>
          <p:cNvSpPr txBox="1"/>
          <p:nvPr/>
        </p:nvSpPr>
        <p:spPr>
          <a:xfrm>
            <a:off x="0" y="37441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3AC9468-0EBA-7582-2A28-FD96B375AD91}"/>
              </a:ext>
            </a:extLst>
          </p:cNvPr>
          <p:cNvSpPr txBox="1"/>
          <p:nvPr/>
        </p:nvSpPr>
        <p:spPr>
          <a:xfrm>
            <a:off x="2302606" y="38046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14DABA8-F2ED-8109-E93B-F9F9093E6466}"/>
              </a:ext>
            </a:extLst>
          </p:cNvPr>
          <p:cNvSpPr txBox="1"/>
          <p:nvPr/>
        </p:nvSpPr>
        <p:spPr>
          <a:xfrm>
            <a:off x="4537698" y="38046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02F099-4C6B-1DCA-1221-BE420E104F42}"/>
              </a:ext>
            </a:extLst>
          </p:cNvPr>
          <p:cNvSpPr txBox="1"/>
          <p:nvPr/>
        </p:nvSpPr>
        <p:spPr>
          <a:xfrm>
            <a:off x="0" y="4098409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AD3A9BE-1A4E-C455-994A-13CEE0D005B5}"/>
              </a:ext>
            </a:extLst>
          </p:cNvPr>
          <p:cNvSpPr txBox="1"/>
          <p:nvPr/>
        </p:nvSpPr>
        <p:spPr>
          <a:xfrm>
            <a:off x="2302606" y="4098409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0797E6E-D4DB-A1CB-E9A7-168D43EF14F3}"/>
              </a:ext>
            </a:extLst>
          </p:cNvPr>
          <p:cNvSpPr txBox="1"/>
          <p:nvPr/>
        </p:nvSpPr>
        <p:spPr>
          <a:xfrm>
            <a:off x="4537698" y="4098409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39F398A8-7D4C-7CE8-B7E8-C8974C2BD4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503" y="4463866"/>
            <a:ext cx="2137649" cy="30816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255A24C-829A-E0B6-CC28-2FC53231E7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37698" y="4473644"/>
            <a:ext cx="2137649" cy="308160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6F6382F0-E61B-A335-65FA-E1868D8ADE9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99100" y="4473644"/>
            <a:ext cx="2137650" cy="308160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0DAB793-83EF-10EB-7E7A-529B7D87E4A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37698" y="755699"/>
            <a:ext cx="2137650" cy="308160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A0E789E1-12F3-5C05-757C-C5FE0577F24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99100" y="743744"/>
            <a:ext cx="2137650" cy="308160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8113FC8-0DBA-4F47-A687-F0D5C313CA3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503" y="759575"/>
            <a:ext cx="2134961" cy="307772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B8F4F1E-BAD5-D6F0-1D1F-866C1091F372}"/>
              </a:ext>
            </a:extLst>
          </p:cNvPr>
          <p:cNvSpPr txBox="1"/>
          <p:nvPr/>
        </p:nvSpPr>
        <p:spPr>
          <a:xfrm>
            <a:off x="0" y="8101012"/>
            <a:ext cx="6858000" cy="7463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300"/>
              </a:spcBef>
            </a:pPr>
            <a:r>
              <a:rPr lang="en-US" sz="10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ure 9. Overlapping T-cell clonotypes in REP TIL and pre-REP TIL samples</a:t>
            </a:r>
            <a:endParaRPr lang="fi-FI" sz="10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>
              <a:spcBef>
                <a:spcPts val="300"/>
              </a:spcBef>
            </a:pPr>
            <a:r>
              <a:rPr lang="en-US" sz="1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he frequencies of the overlapping T-cell clonotypes between the REP TIL and corresponding pre-REP TIL samples for six patients: A) pt081, B) pt096, C) pt125, D) pt423, E) pt426, and F) pt616). The x- and y-axes were scaled using log-transformation and Spearman’s correlation was used to compare the samples.     </a:t>
            </a:r>
            <a:endParaRPr lang="fi-FI" sz="10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3835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992</TotalTime>
  <Words>87</Words>
  <Application>Microsoft Macintosh PowerPoint</Application>
  <PresentationFormat>A4-paperi (210 x 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Käytetyt fontit</vt:lpstr>
      </vt:variant>
      <vt:variant>
        <vt:i4>4</vt:i4>
      </vt:variant>
      <vt:variant>
        <vt:lpstr>Teema</vt:lpstr>
      </vt:variant>
      <vt:variant>
        <vt:i4>1</vt:i4>
      </vt:variant>
      <vt:variant>
        <vt:lpstr>Dian otsikot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esity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Moon Hee</dc:creator>
  <cp:lastModifiedBy>Mustjoki, Satu M</cp:lastModifiedBy>
  <cp:revision>395</cp:revision>
  <dcterms:created xsi:type="dcterms:W3CDTF">2022-10-13T13:05:53Z</dcterms:created>
  <dcterms:modified xsi:type="dcterms:W3CDTF">2023-06-17T07:29:05Z</dcterms:modified>
</cp:coreProperties>
</file>